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01_38082CDD.xml" ContentType="application/vnd.ms-powerpoint.comment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C411A84-AEB3-F8F8-9D6C-CC435C4BB9E0}" name="Word" initials="Word" userId="Word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omments/modernComment_101_38082CDD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EFF15118-9EC3-45E1-8EF3-B2662289E497}" authorId="{6C411A84-AEB3-F8F8-9D6C-CC435C4BB9E0}" created="2022-07-09T01:50:25.068">
    <ac:deMkLst xmlns:ac="http://schemas.microsoft.com/office/drawing/2013/main/command">
      <pc:docMk xmlns:pc="http://schemas.microsoft.com/office/powerpoint/2013/main/command"/>
      <pc:sldMk xmlns:pc="http://schemas.microsoft.com/office/powerpoint/2013/main/command" cId="940059869" sldId="257"/>
      <ac:picMk id="17" creationId="{86B6690A-1F10-D1E8-C72E-F2BBC0910621}"/>
    </ac:deMkLst>
    <p188:txBody>
      <a:bodyPr/>
      <a:lstStyle/>
      <a:p>
        <a:r>
          <a:rPr lang="en-US"/>
          <a:t>PT-1mm, Figure 1B</a:t>
        </a:r>
      </a:p>
    </p188:txBody>
  </p188:cm>
  <p188:cm id="{BE6E3ECB-172D-4CF2-9039-B2A10AEEAA80}" authorId="{6C411A84-AEB3-F8F8-9D6C-CC435C4BB9E0}" created="2022-07-09T01:53:18.505">
    <ac:deMkLst xmlns:ac="http://schemas.microsoft.com/office/drawing/2013/main/command">
      <pc:docMk xmlns:pc="http://schemas.microsoft.com/office/powerpoint/2013/main/command"/>
      <pc:sldMk xmlns:pc="http://schemas.microsoft.com/office/powerpoint/2013/main/command" cId="940059869" sldId="257"/>
      <ac:picMk id="19" creationId="{8A2866FE-6F9A-09FE-C4A2-23DFDA842937}"/>
    </ac:deMkLst>
    <p188:txBody>
      <a:bodyPr/>
      <a:lstStyle/>
      <a:p>
        <a:r>
          <a:rPr lang="en-US"/>
          <a:t>PT-10um, Figure 1C</a:t>
        </a:r>
      </a:p>
    </p188:txBody>
  </p188:cm>
  <p188:cm id="{0253A457-7FAF-4EDB-95FD-0D76B9E3B18B}" authorId="{6C411A84-AEB3-F8F8-9D6C-CC435C4BB9E0}" created="2022-07-09T01:56:29.373">
    <ac:deMkLst xmlns:ac="http://schemas.microsoft.com/office/drawing/2013/main/command">
      <pc:docMk xmlns:pc="http://schemas.microsoft.com/office/powerpoint/2013/main/command"/>
      <pc:sldMk xmlns:pc="http://schemas.microsoft.com/office/powerpoint/2013/main/command" cId="940059869" sldId="257"/>
      <ac:picMk id="21" creationId="{F6AD95EE-3708-8B47-0BF3-EABDD13C235B}"/>
    </ac:deMkLst>
    <p188:txBody>
      <a:bodyPr/>
      <a:lstStyle/>
      <a:p>
        <a:r>
          <a:rPr lang="en-US"/>
          <a:t>Macroscopic view of PT, Figure 1A</a:t>
        </a:r>
      </a:p>
    </p188:txBody>
  </p188:cm>
  <p188:cm id="{9BBA50DA-2E98-4404-9459-6782A732B466}" authorId="{6C411A84-AEB3-F8F8-9D6C-CC435C4BB9E0}" created="2022-07-09T02:01:32.198">
    <ac:deMkLst xmlns:ac="http://schemas.microsoft.com/office/drawing/2013/main/command">
      <pc:docMk xmlns:pc="http://schemas.microsoft.com/office/powerpoint/2013/main/command"/>
      <pc:sldMk xmlns:pc="http://schemas.microsoft.com/office/powerpoint/2013/main/command" cId="940059869" sldId="257"/>
      <ac:picMk id="23" creationId="{32454873-37BE-9ABA-E0B2-DAE68BBB024A}"/>
    </ac:deMkLst>
    <p188:txBody>
      <a:bodyPr/>
      <a:lstStyle/>
      <a:p>
        <a:r>
          <a:rPr lang="en-US"/>
          <a:t>PT-200um, Figure 1D</a:t>
        </a:r>
      </a:p>
    </p188:txBody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3DFA7-E665-5446-7EE6-BC96661137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CD7C0C-1733-924A-FE5F-3545D987F2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55FAA6-1B50-8EB3-753C-4C62AEC56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9C73EC-A26F-D1AD-892B-337B85889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D4AB0A-E570-53FA-2BBF-DF5D33B28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666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900F4D-18A2-40CA-683C-491566137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B706D0-5261-32A6-0FF9-9FE2D4502E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396B2E-9DDC-F7F0-73F6-5E0F3DEE1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FE0CC2-4060-9EB0-F2F9-0B4791BDF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E975C3-9A76-8DB8-1BBE-D82751F3C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803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F942D2-39CE-203D-6A4F-E48E3B195C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F9C666-8BB0-001E-F5BA-34695FE102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E28CBA-307F-2961-494E-A26FCB2CE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4433C3-D9EE-8031-D62F-BD197AAC7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FBAF68-2D01-8F04-62CB-179F8C70E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549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832CF5-DEC5-6244-0AA7-B44A314AED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E4B268-D53D-196B-60AE-4545009FB6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C8303E-9B66-288D-F00E-E59F1A5DA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784156-FC37-2F90-B97A-640D3F5DB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4DFD59-D51B-9562-2614-5C7412EC4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176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424C2B-3BEC-3091-B0E2-C16424FEC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CA7A13-B1B8-16B7-F9AC-41F27305A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C9B32D-3993-27C5-D688-EDCAE1CD9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8115C3-C05A-8CEA-044C-5446C2E38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4835E-C3E7-D211-F60C-1CA2FF713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703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F824CA-D9D8-48F3-28F8-208C5C564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F1A00F-B1E1-CC82-AE56-F71F08CB54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69E307-1794-7A55-BA4F-5C0EA5CEB9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972BAD-C265-D01A-6968-70FD23B69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DEB2B-9440-1021-9EE8-25E89CC4C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DF0739-97E3-401C-928C-4FDE67C62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660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7630C1-EDB2-FC92-F0C0-F16701EEB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960249-5D70-B46A-F747-D688F081A9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F34807-B86C-E85E-B810-8BDB3D00CC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0FB912-67BA-5C60-F17B-12D14A3BD4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A551B0-3197-5392-E0DD-3957B7CFA5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E57639-84A0-4F61-F3C0-208932829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161E72-8441-637E-A6BE-576F951F5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B08FA3-19C3-94CD-D2D1-37207ECD6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820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8701A9-7987-64BE-7B2B-CFEA871967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5AE4BF-874E-7553-C3D1-46A27D6FA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A101A1-1617-BB74-1DCA-84660D77B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E58E48-C84E-D2DC-3BEA-07D5C291D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4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2BC5B6F-4B21-A8D5-708B-B14A59E29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962C8F8-32AE-4EEB-463D-3C67364D5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3F57D32-894E-70A2-DD5A-FAFEAD912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47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4C0248-07B2-8D5E-80FE-968339E150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845BF3-1341-F1B0-2073-F86D2AE07D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9C069C-24DE-7B42-DECA-8F46706B65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3D2E2B-9742-773A-0AD9-46DC086E6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771089-FC7D-0A86-147B-BF6E46372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8BA767-8770-8DC6-63F9-02CF58ADE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40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85DEF0-1B90-90ED-5599-DE8D97579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033693A-CC20-FFF0-DD11-E4AF251DE5B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A33DF2-621B-1652-C820-832ADC7587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2FCD14-F819-9AF9-4AB2-6039A6DFC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4427A5-CE6E-9382-5179-49F424D58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5265D9-4DC3-99DF-8376-5988B390B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553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293457-DE28-7A9C-4BDE-9EF9D349AA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F31C4E-5879-3A55-D3E2-64CA5FD8AF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B850DE-7CB9-4D0F-E65B-401F0B2A23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E93483-2CBB-4C03-96FF-F196190618D5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B817BC-8F66-9ED1-CB1E-07E1C98BF1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262108-1541-382E-113E-AE4678FF48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D662F-7118-4C1B-B42E-CA78BE46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831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microsoft.com/office/2018/10/relationships/comments" Target="../comments/modernComment_101_38082CDD.xml"/><Relationship Id="rId5" Type="http://schemas.openxmlformats.org/officeDocument/2006/relationships/image" Target="../media/image4.tif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81C593-2470-EF55-9CD6-4DE5E134D4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17320" y="1046480"/>
            <a:ext cx="9093200" cy="1330960"/>
          </a:xfrm>
        </p:spPr>
        <p:txBody>
          <a:bodyPr>
            <a:noAutofit/>
          </a:bodyPr>
          <a:lstStyle/>
          <a:p>
            <a:pPr algn="just"/>
            <a:r>
              <a:rPr lang="en-US" sz="2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gineered 3D-printed polyvinyl alcohol scaffolds incorporating β-tricalcium phosphate and icariin induce bone regeneration in rat skull defect model</a:t>
            </a:r>
            <a:endParaRPr lang="en-US" sz="28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12710F-3EC8-961F-B0AD-156B0F95FC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74800" y="3078480"/>
            <a:ext cx="9093200" cy="2804161"/>
          </a:xfrm>
        </p:spPr>
        <p:txBody>
          <a:bodyPr>
            <a:normAutofit fontScale="92500" lnSpcReduction="10000"/>
          </a:bodyPr>
          <a:lstStyle/>
          <a:p>
            <a:pPr algn="l"/>
            <a:r>
              <a:rPr lang="en-US" b="1" dirty="0" err="1"/>
              <a:t>Zhimin</a:t>
            </a:r>
            <a:r>
              <a:rPr lang="en-US" b="1" dirty="0"/>
              <a:t> Xu </a:t>
            </a:r>
            <a:r>
              <a:rPr lang="en-US" b="1" baseline="30000" dirty="0"/>
              <a:t>†</a:t>
            </a:r>
            <a:r>
              <a:rPr lang="en-US" b="1" dirty="0"/>
              <a:t>, </a:t>
            </a:r>
            <a:r>
              <a:rPr lang="en-US" b="1" dirty="0" err="1"/>
              <a:t>Yidan</a:t>
            </a:r>
            <a:r>
              <a:rPr lang="en-US" b="1" dirty="0"/>
              <a:t> Sun </a:t>
            </a:r>
            <a:r>
              <a:rPr lang="en-US" b="1" baseline="30000" dirty="0"/>
              <a:t>†</a:t>
            </a:r>
            <a:r>
              <a:rPr lang="en-US" b="1" dirty="0"/>
              <a:t>, </a:t>
            </a:r>
            <a:r>
              <a:rPr lang="en-US" b="1" dirty="0" err="1"/>
              <a:t>Huanyan</a:t>
            </a:r>
            <a:r>
              <a:rPr lang="en-US" b="1" dirty="0"/>
              <a:t> Dai, </a:t>
            </a:r>
            <a:r>
              <a:rPr lang="en-US" b="1" dirty="0" err="1"/>
              <a:t>Yujie</a:t>
            </a:r>
            <a:r>
              <a:rPr lang="en-US" b="1" dirty="0"/>
              <a:t> Ma and Han Bing *</a:t>
            </a:r>
          </a:p>
          <a:p>
            <a:pPr algn="l"/>
            <a:r>
              <a:rPr lang="en-US" dirty="0"/>
              <a:t>Department of Oral and Maxillofacial Surgery, School and Hospital of Stomatology, Jilin University, </a:t>
            </a:r>
            <a:br>
              <a:rPr lang="en-US" dirty="0"/>
            </a:br>
            <a:r>
              <a:rPr lang="en-US" dirty="0"/>
              <a:t>Changchun 130021, China; xuzhimin@jlu.edu.cn (Z.X.); sunyd18@mails.jlu.edu.cn (Y.S.); daihy20@mails.jlu.edu.cn (H.D.); mayj20@mails.jlu.edu.cn (Y.M.)</a:t>
            </a:r>
          </a:p>
          <a:p>
            <a:pPr algn="l"/>
            <a:r>
              <a:rPr lang="en-US" b="1" dirty="0"/>
              <a:t>*</a:t>
            </a:r>
            <a:r>
              <a:rPr lang="en-US" dirty="0"/>
              <a:t>	Correspondence: hbing@jlu.edu.cn</a:t>
            </a:r>
          </a:p>
          <a:p>
            <a:pPr algn="l"/>
            <a:r>
              <a:rPr lang="en-US" dirty="0"/>
              <a:t>†	These authors contributed equally to this work.</a:t>
            </a:r>
          </a:p>
        </p:txBody>
      </p:sp>
    </p:spTree>
    <p:extLst>
      <p:ext uri="{BB962C8B-B14F-4D97-AF65-F5344CB8AC3E}">
        <p14:creationId xmlns:p14="http://schemas.microsoft.com/office/powerpoint/2010/main" val="3366072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93A29-9232-20C3-5C32-8376EA9FEE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ysical appearance of scaffolds. Macroscopic photos and SEM micrographs of the PT </a:t>
            </a:r>
            <a:r>
              <a:rPr lang="en-IO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,</a:t>
            </a:r>
            <a:r>
              <a:rPr lang="en-IO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B,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 and </a:t>
            </a:r>
            <a:r>
              <a:rPr lang="en-IO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)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omposite scaffolds. </a:t>
            </a:r>
            <a:endParaRPr lang="en-US" dirty="0"/>
          </a:p>
        </p:txBody>
      </p:sp>
      <p:pic>
        <p:nvPicPr>
          <p:cNvPr id="17" name="Content Placeholder 16">
            <a:extLst>
              <a:ext uri="{FF2B5EF4-FFF2-40B4-BE49-F238E27FC236}">
                <a16:creationId xmlns:a16="http://schemas.microsoft.com/office/drawing/2014/main" id="{86B6690A-1F10-D1E8-C72E-F2BBC091062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5849" y="2565521"/>
            <a:ext cx="3077068" cy="2307801"/>
          </a:xfr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A2866FE-6F9A-09FE-C4A2-23DFDA8429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38137" y="2565522"/>
            <a:ext cx="3077067" cy="23078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F6AD95EE-3708-8B47-0BF3-EABDD13C235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5004" y="2565521"/>
            <a:ext cx="2005625" cy="2307801"/>
          </a:xfrm>
          <a:prstGeom prst="rect">
            <a:avLst/>
          </a:prstGeom>
        </p:spPr>
      </p:pic>
      <p:pic>
        <p:nvPicPr>
          <p:cNvPr id="23" name="Picture 22" descr="A close-up of a grey surface&#10;&#10;Description automatically generated with low confidence">
            <a:extLst>
              <a:ext uri="{FF2B5EF4-FFF2-40B4-BE49-F238E27FC236}">
                <a16:creationId xmlns:a16="http://schemas.microsoft.com/office/drawing/2014/main" id="{32454873-37BE-9ABA-E0B2-DAE68BBB024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90423" y="2565521"/>
            <a:ext cx="3077067" cy="23078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99490B4-18DC-4310-B9A8-157D7566E985}"/>
              </a:ext>
            </a:extLst>
          </p:cNvPr>
          <p:cNvSpPr txBox="1"/>
          <p:nvPr/>
        </p:nvSpPr>
        <p:spPr>
          <a:xfrm>
            <a:off x="1171852" y="506915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14A43A8-FF46-4480-8532-D43E5E73ADD4}"/>
              </a:ext>
            </a:extLst>
          </p:cNvPr>
          <p:cNvSpPr txBox="1"/>
          <p:nvPr/>
        </p:nvSpPr>
        <p:spPr>
          <a:xfrm>
            <a:off x="3934287" y="506915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82FD76C-1C1B-4F03-9FAA-3627BB1859ED}"/>
              </a:ext>
            </a:extLst>
          </p:cNvPr>
          <p:cNvSpPr txBox="1"/>
          <p:nvPr/>
        </p:nvSpPr>
        <p:spPr>
          <a:xfrm>
            <a:off x="7021820" y="506915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12FFE4E-CAFF-468D-8223-6AF004A8EEBF}"/>
              </a:ext>
            </a:extLst>
          </p:cNvPr>
          <p:cNvSpPr txBox="1"/>
          <p:nvPr/>
        </p:nvSpPr>
        <p:spPr>
          <a:xfrm>
            <a:off x="10107751" y="510289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940059869"/>
      </p:ext>
    </p:extLst>
  </p:cSld>
  <p:clrMapOvr>
    <a:masterClrMapping/>
  </p:clrMapOvr>
  <p:extLst mod="1">
    <p:ext uri="{6950BFC3-D8DA-4A85-94F7-54DA5524770B}">
      <p188:commentRel xmlns="" xmlns:p188="http://schemas.microsoft.com/office/powerpoint/2018/8/main" r:id="rId6"/>
    </p:ext>
  </p:extLs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81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SimSun</vt:lpstr>
      <vt:lpstr>Arial</vt:lpstr>
      <vt:lpstr>Calibri</vt:lpstr>
      <vt:lpstr>Calibri Light</vt:lpstr>
      <vt:lpstr>Palatino Linotype</vt:lpstr>
      <vt:lpstr>Times New Roman</vt:lpstr>
      <vt:lpstr>Office Theme</vt:lpstr>
      <vt:lpstr>Engineered 3D-printed polyvinyl alcohol scaffolds incorporating β-tricalcium phosphate and icariin induce bone regeneration in rat skull defect model</vt:lpstr>
      <vt:lpstr>Figure S1. Physical appearance of scaffolds. Macroscopic photos and SEM micrographs of the PT (A, B, C and D) composite scaffolds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ngineered 3D-printed polyvinyl alcohol scaffolds incorporating β-tricalcium phosphate and icariin induce bone regeneration in rat skull defect model</dc:title>
  <dc:creator>Word</dc:creator>
  <cp:lastModifiedBy>MDPI</cp:lastModifiedBy>
  <cp:revision>6</cp:revision>
  <dcterms:created xsi:type="dcterms:W3CDTF">2022-07-09T01:47:18Z</dcterms:created>
  <dcterms:modified xsi:type="dcterms:W3CDTF">2022-07-16T02:53:44Z</dcterms:modified>
</cp:coreProperties>
</file>